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41" autoAdjust="0"/>
    <p:restoredTop sz="96138" autoAdjust="0"/>
  </p:normalViewPr>
  <p:slideViewPr>
    <p:cSldViewPr snapToGrid="0">
      <p:cViewPr varScale="1">
        <p:scale>
          <a:sx n="115" d="100"/>
          <a:sy n="115" d="100"/>
        </p:scale>
        <p:origin x="208" y="2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F50F5F-1E19-4E1C-B75C-E83725C15E73}" type="datetimeFigureOut">
              <a:rPr lang="en-US" smtClean="0"/>
              <a:t>8/10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DBF991-CE61-4F6C-8937-BCF5982FC4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5901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60193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Gel 10%</a:t>
            </a:r>
          </a:p>
          <a:p>
            <a:pPr defTabSz="960193">
              <a:defRPr/>
            </a:pPr>
            <a:endParaRPr lang="en-US" b="1" dirty="0"/>
          </a:p>
          <a:p>
            <a:pPr defTabSz="960193">
              <a:defRPr/>
            </a:pPr>
            <a:r>
              <a:rPr lang="en-US" b="1" dirty="0"/>
              <a:t>Antibody and Dilution (CD63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CD63 (Abcam – ab213090) - 1:500</a:t>
            </a:r>
          </a:p>
          <a:p>
            <a:pPr defTabSz="960193">
              <a:defRPr/>
            </a:pPr>
            <a:r>
              <a:rPr lang="en-US" dirty="0"/>
              <a:t>        Secondary: Anti-Mouse - 1:2000</a:t>
            </a:r>
          </a:p>
          <a:p>
            <a:endParaRPr lang="en-US" dirty="0"/>
          </a:p>
          <a:p>
            <a:pPr defTabSz="960193">
              <a:defRPr/>
            </a:pPr>
            <a:r>
              <a:rPr lang="en-US" b="1" dirty="0"/>
              <a:t>Antibody and Dilution (Actin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Actin (Cell signaling – 8H10D10) - 1:2000</a:t>
            </a:r>
          </a:p>
          <a:p>
            <a:pPr defTabSz="960193">
              <a:defRPr/>
            </a:pPr>
            <a:r>
              <a:rPr lang="en-US" dirty="0"/>
              <a:t>        Secondary: Anti-Mouse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r>
              <a:rPr lang="en-US" b="1" dirty="0"/>
              <a:t>Antibody and Dilution (TSG101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TSG (Abcam – ab125011) - 1:250</a:t>
            </a:r>
          </a:p>
          <a:p>
            <a:pPr defTabSz="960193">
              <a:defRPr/>
            </a:pPr>
            <a:r>
              <a:rPr lang="en-US" dirty="0"/>
              <a:t>        Secondary: Anti-Rabbit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DBF991-CE61-4F6C-8937-BCF5982FC49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5293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60193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Gel 10%</a:t>
            </a:r>
          </a:p>
          <a:p>
            <a:pPr marL="0" marR="0" lvl="0" indent="0" algn="l" defTabSz="960193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/>
          </a:p>
          <a:p>
            <a:pPr defTabSz="960193">
              <a:defRPr/>
            </a:pPr>
            <a:r>
              <a:rPr lang="en-US" b="1" dirty="0"/>
              <a:t>Antibody and Dilution (CD63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CD63 (Abcam – ab213090) - 1:500</a:t>
            </a:r>
          </a:p>
          <a:p>
            <a:pPr defTabSz="960193">
              <a:defRPr/>
            </a:pPr>
            <a:r>
              <a:rPr lang="en-US" dirty="0"/>
              <a:t>        Secondary: Anti-Mouse - 1:2000</a:t>
            </a:r>
          </a:p>
          <a:p>
            <a:endParaRPr lang="en-US" dirty="0"/>
          </a:p>
          <a:p>
            <a:pPr defTabSz="960193">
              <a:defRPr/>
            </a:pPr>
            <a:r>
              <a:rPr lang="en-US" b="1" dirty="0"/>
              <a:t>Antibody and Dilution (Actin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Actin (Cell signaling – 8H10D10) - 1:2000</a:t>
            </a:r>
          </a:p>
          <a:p>
            <a:pPr defTabSz="960193">
              <a:defRPr/>
            </a:pPr>
            <a:r>
              <a:rPr lang="en-US" dirty="0"/>
              <a:t>        Secondary: Anti-Mouse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r>
              <a:rPr lang="en-US" b="1" dirty="0"/>
              <a:t>Antibody and Dilution (TSG101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TSG (Abcam – ab125011) - 1:250</a:t>
            </a:r>
          </a:p>
          <a:p>
            <a:pPr defTabSz="960193">
              <a:defRPr/>
            </a:pPr>
            <a:r>
              <a:rPr lang="en-US" dirty="0"/>
              <a:t>        Secondary: Anti-Rabbit - 1:2000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DBF991-CE61-4F6C-8937-BCF5982FC49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70930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60193">
              <a:defRPr/>
            </a:pPr>
            <a:r>
              <a:rPr lang="en-US" b="1" dirty="0"/>
              <a:t>Gel 10%</a:t>
            </a:r>
          </a:p>
          <a:p>
            <a:pPr defTabSz="960193">
              <a:defRPr/>
            </a:pPr>
            <a:endParaRPr lang="en-US" b="1" dirty="0"/>
          </a:p>
          <a:p>
            <a:pPr defTabSz="960193">
              <a:defRPr/>
            </a:pPr>
            <a:r>
              <a:rPr lang="en-US" b="1" dirty="0"/>
              <a:t>Antibody and Dilution (CD63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CD63 (Abcam – ab213090) - 1:500</a:t>
            </a:r>
          </a:p>
          <a:p>
            <a:pPr defTabSz="960193">
              <a:defRPr/>
            </a:pPr>
            <a:r>
              <a:rPr lang="en-US" dirty="0"/>
              <a:t>        Secondary: Anti-Mouse - 1:2000</a:t>
            </a:r>
          </a:p>
          <a:p>
            <a:endParaRPr lang="en-US" dirty="0"/>
          </a:p>
          <a:p>
            <a:pPr defTabSz="960193">
              <a:defRPr/>
            </a:pPr>
            <a:r>
              <a:rPr lang="en-US" b="1" dirty="0"/>
              <a:t>Antibody and Dilution (Actin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Actin (Cell signaling – 8H10D10) - 1:2000</a:t>
            </a:r>
          </a:p>
          <a:p>
            <a:pPr defTabSz="960193">
              <a:defRPr/>
            </a:pPr>
            <a:r>
              <a:rPr lang="en-US" dirty="0"/>
              <a:t>        Secondary: Anti-Mouse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r>
              <a:rPr lang="en-US" b="1" dirty="0"/>
              <a:t>Antibody and Dilution (TSG101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TSG (Abcam – ab125011) - 1:250</a:t>
            </a:r>
          </a:p>
          <a:p>
            <a:pPr defTabSz="960193">
              <a:defRPr/>
            </a:pPr>
            <a:r>
              <a:rPr lang="en-US" dirty="0"/>
              <a:t>        Secondary: Anti-Rabbit - 1:2000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DBF991-CE61-4F6C-8937-BCF5982FC49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0083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04F0F-EFAA-02C7-39F2-B2B9756058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A7D8C1-5CBF-DB08-CA2F-AF2AE8E0928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4A0C31-B823-9030-DB78-7F0C57D75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5F794-72C7-4C70-BEC3-0B6BB33132D5}" type="datetimeFigureOut">
              <a:rPr lang="en-US" smtClean="0"/>
              <a:t>8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C824AF-0302-1205-304C-0BECF603DC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2C59DA-B5F6-B0CB-B774-D380C2466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16B7E-527B-48FE-B05D-BA154C2C89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889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5FCC4C-4FE3-919D-1546-E3ACBDF886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E397A9-7D79-2E68-1F89-C3BD9B7533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8EE5EA-9929-8265-4569-2AD1A19EF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5F794-72C7-4C70-BEC3-0B6BB33132D5}" type="datetimeFigureOut">
              <a:rPr lang="en-US" smtClean="0"/>
              <a:t>8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38CC6C-9DB2-8B71-7292-DD742962B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7FEF8E-03C9-44FC-EC4E-0D40C9611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16B7E-527B-48FE-B05D-BA154C2C89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482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C734C1-B107-2AFC-1352-460A09CE49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DFD963-7670-873D-51BA-6B21CAD8C3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14FD47-E31E-C07D-2212-2D2DC3777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5F794-72C7-4C70-BEC3-0B6BB33132D5}" type="datetimeFigureOut">
              <a:rPr lang="en-US" smtClean="0"/>
              <a:t>8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01196A-075A-738E-CD15-7FEC7E957D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9BA67C-631B-CAD9-BB77-808EC80D5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16B7E-527B-48FE-B05D-BA154C2C89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971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D80903-EB8E-56A8-EC6D-2B626A06ED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9A3999-BC37-F82B-ECB4-7F89CD41D6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85365E-688D-9EF7-2D38-16C49FFDD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5F794-72C7-4C70-BEC3-0B6BB33132D5}" type="datetimeFigureOut">
              <a:rPr lang="en-US" smtClean="0"/>
              <a:t>8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826D07-ACBD-C06E-F6EA-7751DC7D4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DBCC4D-92EC-1A08-E5C9-1574DC3928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16B7E-527B-48FE-B05D-BA154C2C89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470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2EB129-4EAD-931A-79C4-0BC10CCE72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AE2084-E670-4DDA-B970-96C8ADD8C9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B94240-9E5D-B3BB-225E-13CDDED339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5F794-72C7-4C70-BEC3-0B6BB33132D5}" type="datetimeFigureOut">
              <a:rPr lang="en-US" smtClean="0"/>
              <a:t>8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4A1310-56FE-092D-286F-6A5B62813A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7A62D0-C3D8-54DF-7E45-A1A2407D49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16B7E-527B-48FE-B05D-BA154C2C89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782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B1E418-DE62-0A3D-935E-2B07CED34F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6F41F6-CFB9-D113-8687-4906272FC4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CA1092-BE61-10EC-3C3C-A21527CC9D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66A2A7-6BD7-C758-1AF3-31CDA324C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5F794-72C7-4C70-BEC3-0B6BB33132D5}" type="datetimeFigureOut">
              <a:rPr lang="en-US" smtClean="0"/>
              <a:t>8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598E47-4C1D-A181-0A3B-01D17E9B2F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FC5ECE-69F7-BEC2-FB6D-764DBFC7C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16B7E-527B-48FE-B05D-BA154C2C89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9513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28A647-5CE4-3A6B-E3F6-39AFB57547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CA896B-CE26-E7F3-9F77-824B486F88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826767-4215-38CB-2E93-D46ACA3345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5C49846-BF88-F28F-A101-602AC59FCF9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7119DB8-A936-61EF-57E5-D7CC2AAB59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8ABFC8-649F-5321-5EE4-8D057052C0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5F794-72C7-4C70-BEC3-0B6BB33132D5}" type="datetimeFigureOut">
              <a:rPr lang="en-US" smtClean="0"/>
              <a:t>8/1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E7ECC13-5E18-FFC2-B30D-001EEEB77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6410191-E584-6ED7-B862-051B854D9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16B7E-527B-48FE-B05D-BA154C2C89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474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D05EA4-1792-F1B0-3A9A-4412EFDA24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FD83EC-844C-FA23-10A1-2E5B1546C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5F794-72C7-4C70-BEC3-0B6BB33132D5}" type="datetimeFigureOut">
              <a:rPr lang="en-US" smtClean="0"/>
              <a:t>8/1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94A22F-FBC1-9266-1127-625B4170C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173C86F-63CB-ADA8-8F80-45CC9AF64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16B7E-527B-48FE-B05D-BA154C2C89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1609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3CE6769-06FF-CC6E-5C0E-7D426A1CD1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5F794-72C7-4C70-BEC3-0B6BB33132D5}" type="datetimeFigureOut">
              <a:rPr lang="en-US" smtClean="0"/>
              <a:t>8/1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00C045-CCEC-0B75-0819-9D9C14CD5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4BC9652-9121-6FCA-C8F0-F9224EBEB1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16B7E-527B-48FE-B05D-BA154C2C89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799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1B4453-F7C6-CF4F-FF1C-3E308C2F5F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321DC1-CAB1-4620-0F7B-8F247A91DC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D2013D-C6C2-1AE9-60E9-A599B4F011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192B4E-F80F-2415-7F15-6DC5086FB4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5F794-72C7-4C70-BEC3-0B6BB33132D5}" type="datetimeFigureOut">
              <a:rPr lang="en-US" smtClean="0"/>
              <a:t>8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588D3E-DACA-5785-9E8B-ED8092256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515ED4-BA53-6582-B646-F292E9DCC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16B7E-527B-48FE-B05D-BA154C2C89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394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E70A6F-2C6C-6D4A-B6DD-5C4484AA61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007FCA3-220E-D160-2503-7F2E6D3DA8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9CAF6A-71CE-793E-3C26-4B507DC71B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82E5FD-1630-8649-BE7A-20693C17F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5F794-72C7-4C70-BEC3-0B6BB33132D5}" type="datetimeFigureOut">
              <a:rPr lang="en-US" smtClean="0"/>
              <a:t>8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1AA2D2-6AA5-082F-CFDC-7D63B6B8C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333EDE-0B4F-F54F-AC28-E6CA252A5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16B7E-527B-48FE-B05D-BA154C2C89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867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2A10A35-BD27-DEF7-4B28-B16E4FEA3A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AEF242-E9CF-9A38-154E-D175546209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83D534-FD24-4B70-BDD6-6185D61006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65F794-72C7-4C70-BEC3-0B6BB33132D5}" type="datetimeFigureOut">
              <a:rPr lang="en-US" smtClean="0"/>
              <a:t>8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30530A-0D30-ED71-B975-94635FB471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B4DF68-3EF8-C0F4-090D-51FF8FDB01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916B7E-527B-48FE-B05D-BA154C2C89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791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6.wdp"/><Relationship Id="rId3" Type="http://schemas.openxmlformats.org/officeDocument/2006/relationships/image" Target="../media/image4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5.wdp"/><Relationship Id="rId5" Type="http://schemas.openxmlformats.org/officeDocument/2006/relationships/image" Target="../media/image5.png"/><Relationship Id="rId4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microsoft.com/office/2007/relationships/hdphoto" Target="../media/hdphoto8.wdp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microsoft.com/office/2007/relationships/hdphoto" Target="../media/hdphoto7.wdp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5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microsoft.com/office/2007/relationships/hdphoto" Target="../media/hdphoto9.wdp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467A930-18C3-9D03-C277-9E0BE740877E}"/>
              </a:ext>
            </a:extLst>
          </p:cNvPr>
          <p:cNvSpPr txBox="1"/>
          <p:nvPr/>
        </p:nvSpPr>
        <p:spPr>
          <a:xfrm>
            <a:off x="3990660" y="142475"/>
            <a:ext cx="39444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3T3L1 adipocytes – Set 1  </a:t>
            </a:r>
          </a:p>
        </p:txBody>
      </p:sp>
      <p:pic>
        <p:nvPicPr>
          <p:cNvPr id="11" name="Picture 10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C081C8C9-E581-E799-4C5D-3B36EE158DF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31" t="15749" r="8096" b="54849"/>
          <a:stretch/>
        </p:blipFill>
        <p:spPr>
          <a:xfrm>
            <a:off x="6661722" y="1910003"/>
            <a:ext cx="5102148" cy="113737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DC1CECD-F5F5-A1E3-0548-8D761DB8B63C}"/>
              </a:ext>
            </a:extLst>
          </p:cNvPr>
          <p:cNvSpPr txBox="1"/>
          <p:nvPr/>
        </p:nvSpPr>
        <p:spPr>
          <a:xfrm>
            <a:off x="286014" y="2566923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45A7EE4-61BB-589A-DA24-BBF1BB9E67F9}"/>
              </a:ext>
            </a:extLst>
          </p:cNvPr>
          <p:cNvSpPr txBox="1"/>
          <p:nvPr/>
        </p:nvSpPr>
        <p:spPr>
          <a:xfrm>
            <a:off x="286014" y="2125422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37F8859-A1C7-45B8-CA67-91E1FF3CF513}"/>
              </a:ext>
            </a:extLst>
          </p:cNvPr>
          <p:cNvSpPr txBox="1"/>
          <p:nvPr/>
        </p:nvSpPr>
        <p:spPr>
          <a:xfrm>
            <a:off x="258023" y="1979702"/>
            <a:ext cx="7034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34C5CBD-3CAC-3166-B432-66B29D011542}"/>
              </a:ext>
            </a:extLst>
          </p:cNvPr>
          <p:cNvSpPr txBox="1"/>
          <p:nvPr/>
        </p:nvSpPr>
        <p:spPr>
          <a:xfrm>
            <a:off x="261606" y="2959413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57022E5-67EA-CA07-5B3D-2F1D24288E68}"/>
              </a:ext>
            </a:extLst>
          </p:cNvPr>
          <p:cNvSpPr txBox="1"/>
          <p:nvPr/>
        </p:nvSpPr>
        <p:spPr>
          <a:xfrm>
            <a:off x="1299759" y="1425053"/>
            <a:ext cx="63244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ell Medi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CD69812-F8A8-D278-9363-34D346344D41}"/>
              </a:ext>
            </a:extLst>
          </p:cNvPr>
          <p:cNvSpPr txBox="1"/>
          <p:nvPr/>
        </p:nvSpPr>
        <p:spPr>
          <a:xfrm>
            <a:off x="1871775" y="1425053"/>
            <a:ext cx="63244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ell Lysate 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13E0AB0-B28F-3E51-3554-D89A5DBAF983}"/>
              </a:ext>
            </a:extLst>
          </p:cNvPr>
          <p:cNvSpPr txBox="1"/>
          <p:nvPr/>
        </p:nvSpPr>
        <p:spPr>
          <a:xfrm>
            <a:off x="2434193" y="1497426"/>
            <a:ext cx="6324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TR 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9240E60-7AAE-CEF0-5072-94AFCCA32EEF}"/>
              </a:ext>
            </a:extLst>
          </p:cNvPr>
          <p:cNvSpPr txBox="1"/>
          <p:nvPr/>
        </p:nvSpPr>
        <p:spPr>
          <a:xfrm>
            <a:off x="2906220" y="1514217"/>
            <a:ext cx="8394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pNaKtide</a:t>
            </a:r>
            <a:r>
              <a:rPr lang="en-US" sz="1050" dirty="0"/>
              <a:t> 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FE6C743-7D76-6F12-AE7B-9FEB08F7E351}"/>
              </a:ext>
            </a:extLst>
          </p:cNvPr>
          <p:cNvSpPr txBox="1"/>
          <p:nvPr/>
        </p:nvSpPr>
        <p:spPr>
          <a:xfrm>
            <a:off x="3564463" y="1505844"/>
            <a:ext cx="7034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OxLDL</a:t>
            </a:r>
            <a:r>
              <a:rPr lang="en-US" sz="1050" dirty="0"/>
              <a:t> 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631982A-11DC-7D43-7544-484899876C09}"/>
              </a:ext>
            </a:extLst>
          </p:cNvPr>
          <p:cNvSpPr txBox="1"/>
          <p:nvPr/>
        </p:nvSpPr>
        <p:spPr>
          <a:xfrm>
            <a:off x="4207245" y="1416635"/>
            <a:ext cx="78221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OxLDL</a:t>
            </a:r>
            <a:r>
              <a:rPr lang="en-US" sz="1050" dirty="0"/>
              <a:t>+</a:t>
            </a:r>
          </a:p>
          <a:p>
            <a:pPr algn="ctr"/>
            <a:r>
              <a:rPr lang="en-US" sz="1050" dirty="0" err="1"/>
              <a:t>pNaKtide</a:t>
            </a:r>
            <a:r>
              <a:rPr lang="en-US" sz="1050" dirty="0"/>
              <a:t> 1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63BAA0A-317D-9CDD-58E3-39EC7018E7D9}"/>
              </a:ext>
            </a:extLst>
          </p:cNvPr>
          <p:cNvSpPr txBox="1"/>
          <p:nvPr/>
        </p:nvSpPr>
        <p:spPr>
          <a:xfrm>
            <a:off x="7406571" y="1349050"/>
            <a:ext cx="63244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ell Medi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D766F32-7BED-31E5-DB23-53BC8BAFB0A0}"/>
              </a:ext>
            </a:extLst>
          </p:cNvPr>
          <p:cNvSpPr txBox="1"/>
          <p:nvPr/>
        </p:nvSpPr>
        <p:spPr>
          <a:xfrm>
            <a:off x="7931744" y="1349050"/>
            <a:ext cx="63244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ell Lysate 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48D563B-1C2A-DED8-89D6-42B2B3C439EB}"/>
              </a:ext>
            </a:extLst>
          </p:cNvPr>
          <p:cNvSpPr txBox="1"/>
          <p:nvPr/>
        </p:nvSpPr>
        <p:spPr>
          <a:xfrm>
            <a:off x="8509285" y="1429841"/>
            <a:ext cx="6324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TR 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1905159-544E-5F6F-E1E8-BC16C1744569}"/>
              </a:ext>
            </a:extLst>
          </p:cNvPr>
          <p:cNvSpPr txBox="1"/>
          <p:nvPr/>
        </p:nvSpPr>
        <p:spPr>
          <a:xfrm>
            <a:off x="9017719" y="1432472"/>
            <a:ext cx="81063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pNaKtide</a:t>
            </a:r>
            <a:r>
              <a:rPr lang="en-US" sz="1050" dirty="0"/>
              <a:t> 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E197ACB-EB37-EF1D-E1EE-79C1F79FFA45}"/>
              </a:ext>
            </a:extLst>
          </p:cNvPr>
          <p:cNvSpPr txBox="1"/>
          <p:nvPr/>
        </p:nvSpPr>
        <p:spPr>
          <a:xfrm>
            <a:off x="9666481" y="1430018"/>
            <a:ext cx="7034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OxLDL</a:t>
            </a:r>
            <a:r>
              <a:rPr lang="en-US" sz="1050" dirty="0"/>
              <a:t> 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2877CC5-A718-D347-527E-031ADC8AB904}"/>
              </a:ext>
            </a:extLst>
          </p:cNvPr>
          <p:cNvSpPr txBox="1"/>
          <p:nvPr/>
        </p:nvSpPr>
        <p:spPr>
          <a:xfrm>
            <a:off x="10231427" y="1340335"/>
            <a:ext cx="78723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OxLDL</a:t>
            </a:r>
            <a:r>
              <a:rPr lang="en-US" sz="1050" dirty="0"/>
              <a:t>+</a:t>
            </a:r>
          </a:p>
          <a:p>
            <a:pPr algn="ctr"/>
            <a:r>
              <a:rPr lang="en-US" sz="1050" dirty="0" err="1"/>
              <a:t>pNaKtide</a:t>
            </a:r>
            <a:r>
              <a:rPr lang="en-US" sz="1050" dirty="0"/>
              <a:t> 1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D65A6A80-5A92-00AF-8143-B1A64599D334}"/>
              </a:ext>
            </a:extLst>
          </p:cNvPr>
          <p:cNvCxnSpPr>
            <a:cxnSpLocks/>
          </p:cNvCxnSpPr>
          <p:nvPr/>
        </p:nvCxnSpPr>
        <p:spPr>
          <a:xfrm>
            <a:off x="8545900" y="1284385"/>
            <a:ext cx="245447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009C9C84-D1A1-C8F7-2785-2DC99524A9E9}"/>
              </a:ext>
            </a:extLst>
          </p:cNvPr>
          <p:cNvSpPr txBox="1"/>
          <p:nvPr/>
        </p:nvSpPr>
        <p:spPr>
          <a:xfrm>
            <a:off x="3325953" y="1050205"/>
            <a:ext cx="7315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Exosome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AB030CF-31DD-E00C-00F3-0273B8FE75DE}"/>
              </a:ext>
            </a:extLst>
          </p:cNvPr>
          <p:cNvSpPr txBox="1"/>
          <p:nvPr/>
        </p:nvSpPr>
        <p:spPr>
          <a:xfrm>
            <a:off x="9395362" y="1011127"/>
            <a:ext cx="7315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Exosome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B0D3F2B-58DB-1D8D-DC9C-1C26EFA55A76}"/>
              </a:ext>
            </a:extLst>
          </p:cNvPr>
          <p:cNvSpPr txBox="1"/>
          <p:nvPr/>
        </p:nvSpPr>
        <p:spPr>
          <a:xfrm>
            <a:off x="2161936" y="3453143"/>
            <a:ext cx="1470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63 (50kDa)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92B7139-95FC-2E77-D56D-48A018C06AEF}"/>
              </a:ext>
            </a:extLst>
          </p:cNvPr>
          <p:cNvSpPr txBox="1"/>
          <p:nvPr/>
        </p:nvSpPr>
        <p:spPr>
          <a:xfrm>
            <a:off x="8564188" y="3453143"/>
            <a:ext cx="1452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42kDa)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7F7E6181-28FF-25B4-AC91-8E7D9550A085}"/>
              </a:ext>
            </a:extLst>
          </p:cNvPr>
          <p:cNvCxnSpPr>
            <a:cxnSpLocks/>
          </p:cNvCxnSpPr>
          <p:nvPr/>
        </p:nvCxnSpPr>
        <p:spPr>
          <a:xfrm>
            <a:off x="2504219" y="1356312"/>
            <a:ext cx="245447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744AD25A-DDCA-3409-F089-215268D21B21}"/>
              </a:ext>
            </a:extLst>
          </p:cNvPr>
          <p:cNvSpPr txBox="1"/>
          <p:nvPr/>
        </p:nvSpPr>
        <p:spPr>
          <a:xfrm>
            <a:off x="6325971" y="2466188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CB996112-FA39-6F4B-AB0A-72CA87AD2F51}"/>
              </a:ext>
            </a:extLst>
          </p:cNvPr>
          <p:cNvSpPr txBox="1"/>
          <p:nvPr/>
        </p:nvSpPr>
        <p:spPr>
          <a:xfrm>
            <a:off x="6338004" y="2055722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BB16A6D1-5B39-A848-E04B-15CD4976A1DB}"/>
              </a:ext>
            </a:extLst>
          </p:cNvPr>
          <p:cNvSpPr txBox="1"/>
          <p:nvPr/>
        </p:nvSpPr>
        <p:spPr>
          <a:xfrm>
            <a:off x="6310013" y="1910002"/>
            <a:ext cx="7034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4D922032-B5CA-79E0-5C47-1BBE812EECF6}"/>
              </a:ext>
            </a:extLst>
          </p:cNvPr>
          <p:cNvSpPr txBox="1"/>
          <p:nvPr/>
        </p:nvSpPr>
        <p:spPr>
          <a:xfrm>
            <a:off x="6321597" y="2758245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pic>
        <p:nvPicPr>
          <p:cNvPr id="3" name="Picture 2" descr="A close-up of a document&#10;&#10;Description automatically generated with low confidence">
            <a:extLst>
              <a:ext uri="{FF2B5EF4-FFF2-40B4-BE49-F238E27FC236}">
                <a16:creationId xmlns:a16="http://schemas.microsoft.com/office/drawing/2014/main" id="{DC8F5D5B-9A9A-D3AD-4A6F-D6D4F8AB5DE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41000"/>
                    </a14:imgEffect>
                    <a14:imgEffect>
                      <a14:saturation sat="190000"/>
                    </a14:imgEffect>
                    <a14:imgEffect>
                      <a14:brightnessContrast bright="21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4954" b="49734"/>
          <a:stretch/>
        </p:blipFill>
        <p:spPr>
          <a:xfrm>
            <a:off x="3780878" y="4486124"/>
            <a:ext cx="4300838" cy="76257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F316EFE-8FA4-1BE6-1C9C-E2D6244B83BF}"/>
              </a:ext>
            </a:extLst>
          </p:cNvPr>
          <p:cNvSpPr txBox="1"/>
          <p:nvPr/>
        </p:nvSpPr>
        <p:spPr>
          <a:xfrm>
            <a:off x="5308979" y="5413071"/>
            <a:ext cx="1683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SG101 (44kDa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7B8A3B1-90DE-49F5-BA66-6B33EC059E08}"/>
              </a:ext>
            </a:extLst>
          </p:cNvPr>
          <p:cNvSpPr txBox="1"/>
          <p:nvPr/>
        </p:nvSpPr>
        <p:spPr>
          <a:xfrm>
            <a:off x="3422858" y="4616773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977C154-CE25-29C2-122A-EE6A77E23EA3}"/>
              </a:ext>
            </a:extLst>
          </p:cNvPr>
          <p:cNvSpPr txBox="1"/>
          <p:nvPr/>
        </p:nvSpPr>
        <p:spPr>
          <a:xfrm>
            <a:off x="3418484" y="4963694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pic>
        <p:nvPicPr>
          <p:cNvPr id="5" name="Picture 4" descr="A close-up of a document&#10;&#10;Description automatically generated with low confidence">
            <a:extLst>
              <a:ext uri="{FF2B5EF4-FFF2-40B4-BE49-F238E27FC236}">
                <a16:creationId xmlns:a16="http://schemas.microsoft.com/office/drawing/2014/main" id="{2790F715-4130-0D18-2ED6-6397DCB7DD7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3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61" t="13090" r="2807" b="45467"/>
          <a:stretch/>
        </p:blipFill>
        <p:spPr>
          <a:xfrm>
            <a:off x="680019" y="1897306"/>
            <a:ext cx="4850260" cy="13445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73715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9A88995-AD23-F1F2-D577-475AF9209FD7}"/>
              </a:ext>
            </a:extLst>
          </p:cNvPr>
          <p:cNvSpPr txBox="1"/>
          <p:nvPr/>
        </p:nvSpPr>
        <p:spPr>
          <a:xfrm>
            <a:off x="3990660" y="142475"/>
            <a:ext cx="39444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3T3L1 adipocytes – Set 2 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0BC95A5-4802-D857-26BA-9E09CCAF607D}"/>
              </a:ext>
            </a:extLst>
          </p:cNvPr>
          <p:cNvSpPr txBox="1"/>
          <p:nvPr/>
        </p:nvSpPr>
        <p:spPr>
          <a:xfrm>
            <a:off x="2170272" y="3299363"/>
            <a:ext cx="1470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63 (50kDa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F65C599-B0CA-C971-6BEB-E27888A5900A}"/>
              </a:ext>
            </a:extLst>
          </p:cNvPr>
          <p:cNvSpPr txBox="1"/>
          <p:nvPr/>
        </p:nvSpPr>
        <p:spPr>
          <a:xfrm>
            <a:off x="8752500" y="3637687"/>
            <a:ext cx="1452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42kDa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0EDB62D-CDAC-E743-334F-E18FFD79E488}"/>
              </a:ext>
            </a:extLst>
          </p:cNvPr>
          <p:cNvSpPr txBox="1"/>
          <p:nvPr/>
        </p:nvSpPr>
        <p:spPr>
          <a:xfrm>
            <a:off x="183407" y="2582142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1D6AA9-CA6B-6C05-84CC-4F97A808DCEF}"/>
              </a:ext>
            </a:extLst>
          </p:cNvPr>
          <p:cNvSpPr txBox="1"/>
          <p:nvPr/>
        </p:nvSpPr>
        <p:spPr>
          <a:xfrm>
            <a:off x="186931" y="2160364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9B3E517-7104-5E2E-8788-5A28B4A43CAD}"/>
              </a:ext>
            </a:extLst>
          </p:cNvPr>
          <p:cNvSpPr txBox="1"/>
          <p:nvPr/>
        </p:nvSpPr>
        <p:spPr>
          <a:xfrm>
            <a:off x="158940" y="2014644"/>
            <a:ext cx="7034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4B23609-AA95-451D-0A53-01A2A2EB0099}"/>
              </a:ext>
            </a:extLst>
          </p:cNvPr>
          <p:cNvSpPr txBox="1"/>
          <p:nvPr/>
        </p:nvSpPr>
        <p:spPr>
          <a:xfrm>
            <a:off x="179033" y="2929063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F75912E-EEB4-EF7F-F855-3A509731C440}"/>
              </a:ext>
            </a:extLst>
          </p:cNvPr>
          <p:cNvSpPr txBox="1"/>
          <p:nvPr/>
        </p:nvSpPr>
        <p:spPr>
          <a:xfrm>
            <a:off x="6380007" y="2471525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E1A3D87-9120-D2CB-26CF-01CD49FCDDD1}"/>
              </a:ext>
            </a:extLst>
          </p:cNvPr>
          <p:cNvSpPr txBox="1"/>
          <p:nvPr/>
        </p:nvSpPr>
        <p:spPr>
          <a:xfrm>
            <a:off x="6383531" y="2095467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F172779-F2F1-CE3C-FD5C-3302D9C92840}"/>
              </a:ext>
            </a:extLst>
          </p:cNvPr>
          <p:cNvSpPr txBox="1"/>
          <p:nvPr/>
        </p:nvSpPr>
        <p:spPr>
          <a:xfrm>
            <a:off x="6355540" y="1931459"/>
            <a:ext cx="7034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7650753-8311-6209-E3A3-CB6523F23C0F}"/>
              </a:ext>
            </a:extLst>
          </p:cNvPr>
          <p:cNvSpPr txBox="1"/>
          <p:nvPr/>
        </p:nvSpPr>
        <p:spPr>
          <a:xfrm>
            <a:off x="6375633" y="2818446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2ED3A2D-F49B-9ABB-2B02-AE29873CE392}"/>
              </a:ext>
            </a:extLst>
          </p:cNvPr>
          <p:cNvSpPr txBox="1"/>
          <p:nvPr/>
        </p:nvSpPr>
        <p:spPr>
          <a:xfrm>
            <a:off x="1228120" y="1395736"/>
            <a:ext cx="63244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ell Medi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656B84D-FF8C-223E-4CFA-7204AC979CEF}"/>
              </a:ext>
            </a:extLst>
          </p:cNvPr>
          <p:cNvSpPr txBox="1"/>
          <p:nvPr/>
        </p:nvSpPr>
        <p:spPr>
          <a:xfrm>
            <a:off x="1800136" y="1395736"/>
            <a:ext cx="63244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ell Lysate 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42492DA-C8BA-2F22-218C-3B1B1C2987B1}"/>
              </a:ext>
            </a:extLst>
          </p:cNvPr>
          <p:cNvSpPr txBox="1"/>
          <p:nvPr/>
        </p:nvSpPr>
        <p:spPr>
          <a:xfrm>
            <a:off x="2362554" y="1468109"/>
            <a:ext cx="6324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TR 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7CEAC86-5419-4ED0-0EB2-1E37E8A3AFFB}"/>
              </a:ext>
            </a:extLst>
          </p:cNvPr>
          <p:cNvSpPr txBox="1"/>
          <p:nvPr/>
        </p:nvSpPr>
        <p:spPr>
          <a:xfrm>
            <a:off x="2834581" y="1484900"/>
            <a:ext cx="8394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pNaKtide</a:t>
            </a:r>
            <a:r>
              <a:rPr lang="en-US" sz="1050" dirty="0"/>
              <a:t> 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0203834-C5E1-2CEA-3F52-DBC35E2FF098}"/>
              </a:ext>
            </a:extLst>
          </p:cNvPr>
          <p:cNvSpPr txBox="1"/>
          <p:nvPr/>
        </p:nvSpPr>
        <p:spPr>
          <a:xfrm>
            <a:off x="3492824" y="1476527"/>
            <a:ext cx="7034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OxLDL</a:t>
            </a:r>
            <a:r>
              <a:rPr lang="en-US" sz="1050" dirty="0"/>
              <a:t> 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17E3E5F-BEEF-8A74-D20C-A6E1B2F4BE09}"/>
              </a:ext>
            </a:extLst>
          </p:cNvPr>
          <p:cNvSpPr txBox="1"/>
          <p:nvPr/>
        </p:nvSpPr>
        <p:spPr>
          <a:xfrm>
            <a:off x="4135606" y="1387318"/>
            <a:ext cx="78221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OxLDL</a:t>
            </a:r>
            <a:r>
              <a:rPr lang="en-US" sz="1050" dirty="0"/>
              <a:t>+</a:t>
            </a:r>
          </a:p>
          <a:p>
            <a:pPr algn="ctr"/>
            <a:r>
              <a:rPr lang="en-US" sz="1050" dirty="0" err="1"/>
              <a:t>pNaKtide</a:t>
            </a:r>
            <a:r>
              <a:rPr lang="en-US" sz="1050" dirty="0"/>
              <a:t> 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DF942A6-D017-EDF3-2157-3099E61F0D80}"/>
              </a:ext>
            </a:extLst>
          </p:cNvPr>
          <p:cNvSpPr txBox="1"/>
          <p:nvPr/>
        </p:nvSpPr>
        <p:spPr>
          <a:xfrm>
            <a:off x="3254314" y="1020888"/>
            <a:ext cx="7315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Exosome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5F379F36-E53D-74EF-0708-E6E8FA910760}"/>
              </a:ext>
            </a:extLst>
          </p:cNvPr>
          <p:cNvCxnSpPr>
            <a:cxnSpLocks/>
          </p:cNvCxnSpPr>
          <p:nvPr/>
        </p:nvCxnSpPr>
        <p:spPr>
          <a:xfrm>
            <a:off x="2432580" y="1326995"/>
            <a:ext cx="245447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D8391313-512E-CA1B-ACC1-27AE93B481E9}"/>
              </a:ext>
            </a:extLst>
          </p:cNvPr>
          <p:cNvSpPr txBox="1"/>
          <p:nvPr/>
        </p:nvSpPr>
        <p:spPr>
          <a:xfrm>
            <a:off x="7461280" y="1408731"/>
            <a:ext cx="63244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ell Medi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FFA1B97-7B30-21F7-5199-BD652C8811C4}"/>
              </a:ext>
            </a:extLst>
          </p:cNvPr>
          <p:cNvSpPr txBox="1"/>
          <p:nvPr/>
        </p:nvSpPr>
        <p:spPr>
          <a:xfrm>
            <a:off x="8033296" y="1408731"/>
            <a:ext cx="63244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ell Lysate 2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0EAD6A6-6875-442C-DDF6-B1A8B29EDF8A}"/>
              </a:ext>
            </a:extLst>
          </p:cNvPr>
          <p:cNvSpPr txBox="1"/>
          <p:nvPr/>
        </p:nvSpPr>
        <p:spPr>
          <a:xfrm>
            <a:off x="8595714" y="1481104"/>
            <a:ext cx="6324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TR 2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7449ED2-0C35-6597-071B-459FF6400D0C}"/>
              </a:ext>
            </a:extLst>
          </p:cNvPr>
          <p:cNvSpPr txBox="1"/>
          <p:nvPr/>
        </p:nvSpPr>
        <p:spPr>
          <a:xfrm>
            <a:off x="9067741" y="1497895"/>
            <a:ext cx="8394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pNaKtide</a:t>
            </a:r>
            <a:r>
              <a:rPr lang="en-US" sz="1050" dirty="0"/>
              <a:t> 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1D1E8007-0B1B-1950-9477-9191BFA36E53}"/>
              </a:ext>
            </a:extLst>
          </p:cNvPr>
          <p:cNvSpPr txBox="1"/>
          <p:nvPr/>
        </p:nvSpPr>
        <p:spPr>
          <a:xfrm>
            <a:off x="9725984" y="1489522"/>
            <a:ext cx="7034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OxLDL</a:t>
            </a:r>
            <a:r>
              <a:rPr lang="en-US" sz="1050" dirty="0"/>
              <a:t> 2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FE3711E-D429-BCC0-F65B-4584100F3D3E}"/>
              </a:ext>
            </a:extLst>
          </p:cNvPr>
          <p:cNvSpPr txBox="1"/>
          <p:nvPr/>
        </p:nvSpPr>
        <p:spPr>
          <a:xfrm>
            <a:off x="10368766" y="1400313"/>
            <a:ext cx="78221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OxLDL</a:t>
            </a:r>
            <a:r>
              <a:rPr lang="en-US" sz="1050" dirty="0"/>
              <a:t>+</a:t>
            </a:r>
          </a:p>
          <a:p>
            <a:pPr algn="ctr"/>
            <a:r>
              <a:rPr lang="en-US" sz="1050" dirty="0" err="1"/>
              <a:t>pNaKtide</a:t>
            </a:r>
            <a:r>
              <a:rPr lang="en-US" sz="1050" dirty="0"/>
              <a:t> 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C944272-283B-5BC2-1DEC-83882C62B91C}"/>
              </a:ext>
            </a:extLst>
          </p:cNvPr>
          <p:cNvSpPr txBox="1"/>
          <p:nvPr/>
        </p:nvSpPr>
        <p:spPr>
          <a:xfrm>
            <a:off x="9487474" y="1033883"/>
            <a:ext cx="7315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Exosome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878922EB-C46A-8F30-9D4F-BF6EBA15BA6F}"/>
              </a:ext>
            </a:extLst>
          </p:cNvPr>
          <p:cNvCxnSpPr>
            <a:cxnSpLocks/>
          </p:cNvCxnSpPr>
          <p:nvPr/>
        </p:nvCxnSpPr>
        <p:spPr>
          <a:xfrm>
            <a:off x="8665740" y="1339990"/>
            <a:ext cx="245447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" name="Picture 3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1FD105FA-88DE-697E-72BE-431562539CE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3000"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42" t="9898" r="2723" b="57394"/>
          <a:stretch/>
        </p:blipFill>
        <p:spPr>
          <a:xfrm>
            <a:off x="6830226" y="1941978"/>
            <a:ext cx="4718265" cy="114314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5AC0E94-1C15-BBB6-7FD2-5254BCC65DDE}"/>
              </a:ext>
            </a:extLst>
          </p:cNvPr>
          <p:cNvSpPr txBox="1"/>
          <p:nvPr/>
        </p:nvSpPr>
        <p:spPr>
          <a:xfrm>
            <a:off x="5541569" y="5580286"/>
            <a:ext cx="1683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SG101 (44kDa)</a:t>
            </a:r>
          </a:p>
        </p:txBody>
      </p:sp>
      <p:pic>
        <p:nvPicPr>
          <p:cNvPr id="12" name="Picture 11" descr="A close-up of a tombstone&#10;&#10;Description automatically generated with medium confidence">
            <a:extLst>
              <a:ext uri="{FF2B5EF4-FFF2-40B4-BE49-F238E27FC236}">
                <a16:creationId xmlns:a16="http://schemas.microsoft.com/office/drawing/2014/main" id="{9EA662E8-517B-2C70-583B-97E437DBABF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38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67" t="28284" r="6607" b="50368"/>
          <a:stretch/>
        </p:blipFill>
        <p:spPr>
          <a:xfrm>
            <a:off x="3877449" y="4614639"/>
            <a:ext cx="4718266" cy="826122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9E13FD17-06B7-C4BC-6C26-69DDAAE52DD6}"/>
              </a:ext>
            </a:extLst>
          </p:cNvPr>
          <p:cNvSpPr txBox="1"/>
          <p:nvPr/>
        </p:nvSpPr>
        <p:spPr>
          <a:xfrm>
            <a:off x="3204339" y="4720692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FF3B0CC-B70B-4BA3-EFB2-3C2E976C2540}"/>
              </a:ext>
            </a:extLst>
          </p:cNvPr>
          <p:cNvSpPr txBox="1"/>
          <p:nvPr/>
        </p:nvSpPr>
        <p:spPr>
          <a:xfrm>
            <a:off x="3199965" y="5067613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BCE34EBD-5D6B-23B4-9BF5-A1CBDB90268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-15000"/>
                    </a14:imgEffect>
                    <a14:imgEffect>
                      <a14:brightnessContrast bright="17000" contrast="2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62" t="10878" r="1742" b="53098"/>
          <a:stretch/>
        </p:blipFill>
        <p:spPr>
          <a:xfrm>
            <a:off x="714744" y="1996427"/>
            <a:ext cx="4798769" cy="11634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1714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9A88995-AD23-F1F2-D577-475AF9209FD7}"/>
              </a:ext>
            </a:extLst>
          </p:cNvPr>
          <p:cNvSpPr txBox="1"/>
          <p:nvPr/>
        </p:nvSpPr>
        <p:spPr>
          <a:xfrm>
            <a:off x="3990660" y="142475"/>
            <a:ext cx="39444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3T3L1 adipocytes – Set 3 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0BC95A5-4802-D857-26BA-9E09CCAF607D}"/>
              </a:ext>
            </a:extLst>
          </p:cNvPr>
          <p:cNvSpPr txBox="1"/>
          <p:nvPr/>
        </p:nvSpPr>
        <p:spPr>
          <a:xfrm>
            <a:off x="2213706" y="3392424"/>
            <a:ext cx="1470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63 (50kDa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F65C599-B0CA-C971-6BEB-E27888A5900A}"/>
              </a:ext>
            </a:extLst>
          </p:cNvPr>
          <p:cNvSpPr txBox="1"/>
          <p:nvPr/>
        </p:nvSpPr>
        <p:spPr>
          <a:xfrm>
            <a:off x="8656583" y="3429000"/>
            <a:ext cx="1452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42kDa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0EDB62D-CDAC-E743-334F-E18FFD79E488}"/>
              </a:ext>
            </a:extLst>
          </p:cNvPr>
          <p:cNvSpPr txBox="1"/>
          <p:nvPr/>
        </p:nvSpPr>
        <p:spPr>
          <a:xfrm>
            <a:off x="156191" y="2535503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1D6AA9-CA6B-6C05-84CC-4F97A808DCEF}"/>
              </a:ext>
            </a:extLst>
          </p:cNvPr>
          <p:cNvSpPr txBox="1"/>
          <p:nvPr/>
        </p:nvSpPr>
        <p:spPr>
          <a:xfrm>
            <a:off x="159715" y="2113725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9B3E517-7104-5E2E-8788-5A28B4A43CAD}"/>
              </a:ext>
            </a:extLst>
          </p:cNvPr>
          <p:cNvSpPr txBox="1"/>
          <p:nvPr/>
        </p:nvSpPr>
        <p:spPr>
          <a:xfrm>
            <a:off x="131724" y="1968005"/>
            <a:ext cx="7034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4B23609-AA95-451D-0A53-01A2A2EB0099}"/>
              </a:ext>
            </a:extLst>
          </p:cNvPr>
          <p:cNvSpPr txBox="1"/>
          <p:nvPr/>
        </p:nvSpPr>
        <p:spPr>
          <a:xfrm>
            <a:off x="151817" y="2882424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F75912E-EEB4-EF7F-F855-3A509731C440}"/>
              </a:ext>
            </a:extLst>
          </p:cNvPr>
          <p:cNvSpPr txBox="1"/>
          <p:nvPr/>
        </p:nvSpPr>
        <p:spPr>
          <a:xfrm>
            <a:off x="6486109" y="2451276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E1A3D87-9120-D2CB-26CF-01CD49FCDDD1}"/>
              </a:ext>
            </a:extLst>
          </p:cNvPr>
          <p:cNvSpPr txBox="1"/>
          <p:nvPr/>
        </p:nvSpPr>
        <p:spPr>
          <a:xfrm>
            <a:off x="6489633" y="2075218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F172779-F2F1-CE3C-FD5C-3302D9C92840}"/>
              </a:ext>
            </a:extLst>
          </p:cNvPr>
          <p:cNvSpPr txBox="1"/>
          <p:nvPr/>
        </p:nvSpPr>
        <p:spPr>
          <a:xfrm>
            <a:off x="6461642" y="1911210"/>
            <a:ext cx="7034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7650753-8311-6209-E3A3-CB6523F23C0F}"/>
              </a:ext>
            </a:extLst>
          </p:cNvPr>
          <p:cNvSpPr txBox="1"/>
          <p:nvPr/>
        </p:nvSpPr>
        <p:spPr>
          <a:xfrm>
            <a:off x="6481735" y="2798197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2ED3A2D-F49B-9ABB-2B02-AE29873CE392}"/>
              </a:ext>
            </a:extLst>
          </p:cNvPr>
          <p:cNvSpPr txBox="1"/>
          <p:nvPr/>
        </p:nvSpPr>
        <p:spPr>
          <a:xfrm>
            <a:off x="1259651" y="1410156"/>
            <a:ext cx="63244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ell Medi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656B84D-FF8C-223E-4CFA-7204AC979CEF}"/>
              </a:ext>
            </a:extLst>
          </p:cNvPr>
          <p:cNvSpPr txBox="1"/>
          <p:nvPr/>
        </p:nvSpPr>
        <p:spPr>
          <a:xfrm>
            <a:off x="1831667" y="1410156"/>
            <a:ext cx="63244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ell Lysate 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42492DA-C8BA-2F22-218C-3B1B1C2987B1}"/>
              </a:ext>
            </a:extLst>
          </p:cNvPr>
          <p:cNvSpPr txBox="1"/>
          <p:nvPr/>
        </p:nvSpPr>
        <p:spPr>
          <a:xfrm>
            <a:off x="2394085" y="1482529"/>
            <a:ext cx="6324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TR 3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7CEAC86-5419-4ED0-0EB2-1E37E8A3AFFB}"/>
              </a:ext>
            </a:extLst>
          </p:cNvPr>
          <p:cNvSpPr txBox="1"/>
          <p:nvPr/>
        </p:nvSpPr>
        <p:spPr>
          <a:xfrm>
            <a:off x="2866112" y="1499320"/>
            <a:ext cx="8394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pNaKtide</a:t>
            </a:r>
            <a:r>
              <a:rPr lang="en-US" sz="1050" dirty="0"/>
              <a:t> 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0203834-C5E1-2CEA-3F52-DBC35E2FF098}"/>
              </a:ext>
            </a:extLst>
          </p:cNvPr>
          <p:cNvSpPr txBox="1"/>
          <p:nvPr/>
        </p:nvSpPr>
        <p:spPr>
          <a:xfrm>
            <a:off x="3524355" y="1490947"/>
            <a:ext cx="7034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OxLDL</a:t>
            </a:r>
            <a:r>
              <a:rPr lang="en-US" sz="1050" dirty="0"/>
              <a:t> 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17E3E5F-BEEF-8A74-D20C-A6E1B2F4BE09}"/>
              </a:ext>
            </a:extLst>
          </p:cNvPr>
          <p:cNvSpPr txBox="1"/>
          <p:nvPr/>
        </p:nvSpPr>
        <p:spPr>
          <a:xfrm>
            <a:off x="4167137" y="1401738"/>
            <a:ext cx="78221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OxLDL</a:t>
            </a:r>
            <a:r>
              <a:rPr lang="en-US" sz="1050" dirty="0"/>
              <a:t>+</a:t>
            </a:r>
          </a:p>
          <a:p>
            <a:pPr algn="ctr"/>
            <a:r>
              <a:rPr lang="en-US" sz="1050" dirty="0" err="1"/>
              <a:t>pNaKtide</a:t>
            </a:r>
            <a:r>
              <a:rPr lang="en-US" sz="1050" dirty="0"/>
              <a:t> 3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DF942A6-D017-EDF3-2157-3099E61F0D80}"/>
              </a:ext>
            </a:extLst>
          </p:cNvPr>
          <p:cNvSpPr txBox="1"/>
          <p:nvPr/>
        </p:nvSpPr>
        <p:spPr>
          <a:xfrm>
            <a:off x="3285845" y="1035308"/>
            <a:ext cx="7315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Exosome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5F379F36-E53D-74EF-0708-E6E8FA910760}"/>
              </a:ext>
            </a:extLst>
          </p:cNvPr>
          <p:cNvCxnSpPr>
            <a:cxnSpLocks/>
          </p:cNvCxnSpPr>
          <p:nvPr/>
        </p:nvCxnSpPr>
        <p:spPr>
          <a:xfrm>
            <a:off x="2464111" y="1341415"/>
            <a:ext cx="245447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D8391313-512E-CA1B-ACC1-27AE93B481E9}"/>
              </a:ext>
            </a:extLst>
          </p:cNvPr>
          <p:cNvSpPr txBox="1"/>
          <p:nvPr/>
        </p:nvSpPr>
        <p:spPr>
          <a:xfrm>
            <a:off x="7492811" y="1423151"/>
            <a:ext cx="63244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ell Medi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FFA1B97-7B30-21F7-5199-BD652C8811C4}"/>
              </a:ext>
            </a:extLst>
          </p:cNvPr>
          <p:cNvSpPr txBox="1"/>
          <p:nvPr/>
        </p:nvSpPr>
        <p:spPr>
          <a:xfrm>
            <a:off x="8064827" y="1423151"/>
            <a:ext cx="63244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ell Lysate 3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0EAD6A6-6875-442C-DDF6-B1A8B29EDF8A}"/>
              </a:ext>
            </a:extLst>
          </p:cNvPr>
          <p:cNvSpPr txBox="1"/>
          <p:nvPr/>
        </p:nvSpPr>
        <p:spPr>
          <a:xfrm>
            <a:off x="8627245" y="1495524"/>
            <a:ext cx="6324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TR 3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7449ED2-0C35-6597-071B-459FF6400D0C}"/>
              </a:ext>
            </a:extLst>
          </p:cNvPr>
          <p:cNvSpPr txBox="1"/>
          <p:nvPr/>
        </p:nvSpPr>
        <p:spPr>
          <a:xfrm>
            <a:off x="9099272" y="1512315"/>
            <a:ext cx="8394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pNaKtide</a:t>
            </a:r>
            <a:r>
              <a:rPr lang="en-US" sz="1050" dirty="0"/>
              <a:t> 3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1D1E8007-0B1B-1950-9477-9191BFA36E53}"/>
              </a:ext>
            </a:extLst>
          </p:cNvPr>
          <p:cNvSpPr txBox="1"/>
          <p:nvPr/>
        </p:nvSpPr>
        <p:spPr>
          <a:xfrm>
            <a:off x="9757515" y="1503942"/>
            <a:ext cx="7034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OxLDL</a:t>
            </a:r>
            <a:r>
              <a:rPr lang="en-US" sz="1050" dirty="0"/>
              <a:t> 3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FE3711E-D429-BCC0-F65B-4584100F3D3E}"/>
              </a:ext>
            </a:extLst>
          </p:cNvPr>
          <p:cNvSpPr txBox="1"/>
          <p:nvPr/>
        </p:nvSpPr>
        <p:spPr>
          <a:xfrm>
            <a:off x="10400297" y="1414733"/>
            <a:ext cx="78221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err="1"/>
              <a:t>OxLDL</a:t>
            </a:r>
            <a:r>
              <a:rPr lang="en-US" sz="1050" dirty="0"/>
              <a:t>+</a:t>
            </a:r>
          </a:p>
          <a:p>
            <a:pPr algn="ctr"/>
            <a:r>
              <a:rPr lang="en-US" sz="1050" dirty="0" err="1"/>
              <a:t>pNaKtide</a:t>
            </a:r>
            <a:r>
              <a:rPr lang="en-US" sz="1050" dirty="0"/>
              <a:t> 3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C944272-283B-5BC2-1DEC-83882C62B91C}"/>
              </a:ext>
            </a:extLst>
          </p:cNvPr>
          <p:cNvSpPr txBox="1"/>
          <p:nvPr/>
        </p:nvSpPr>
        <p:spPr>
          <a:xfrm>
            <a:off x="9519005" y="1048303"/>
            <a:ext cx="7315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Exosome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878922EB-C46A-8F30-9D4F-BF6EBA15BA6F}"/>
              </a:ext>
            </a:extLst>
          </p:cNvPr>
          <p:cNvCxnSpPr>
            <a:cxnSpLocks/>
          </p:cNvCxnSpPr>
          <p:nvPr/>
        </p:nvCxnSpPr>
        <p:spPr>
          <a:xfrm>
            <a:off x="8697271" y="1354410"/>
            <a:ext cx="245447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8" name="Picture 17" descr="A picture containing text&#10;&#10;Description automatically generated">
            <a:extLst>
              <a:ext uri="{FF2B5EF4-FFF2-40B4-BE49-F238E27FC236}">
                <a16:creationId xmlns:a16="http://schemas.microsoft.com/office/drawing/2014/main" id="{FFE66EEE-A9F9-FEEE-AF8F-1A4B0FD2658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998" r="729" b="49533"/>
          <a:stretch/>
        </p:blipFill>
        <p:spPr>
          <a:xfrm>
            <a:off x="661918" y="1919106"/>
            <a:ext cx="4513487" cy="1335483"/>
          </a:xfrm>
          <a:prstGeom prst="rect">
            <a:avLst/>
          </a:prstGeom>
        </p:spPr>
      </p:pic>
      <p:pic>
        <p:nvPicPr>
          <p:cNvPr id="22" name="Picture 21" descr="A picture containing text&#10;&#10;Description automatically generated">
            <a:extLst>
              <a:ext uri="{FF2B5EF4-FFF2-40B4-BE49-F238E27FC236}">
                <a16:creationId xmlns:a16="http://schemas.microsoft.com/office/drawing/2014/main" id="{F0CADC8F-61C5-412A-7665-CA0B24ADD6E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14000"/>
                    </a14:imgEffect>
                    <a14:imgEffect>
                      <a14:brightnessContrast bright="20000" contrast="5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51" t="24002" r="2522" b="57906"/>
          <a:stretch/>
        </p:blipFill>
        <p:spPr>
          <a:xfrm>
            <a:off x="3458952" y="4554223"/>
            <a:ext cx="4901213" cy="804457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E0606E19-DC0C-8D75-D53B-3A788623831F}"/>
              </a:ext>
            </a:extLst>
          </p:cNvPr>
          <p:cNvSpPr txBox="1"/>
          <p:nvPr/>
        </p:nvSpPr>
        <p:spPr>
          <a:xfrm>
            <a:off x="5308979" y="5413071"/>
            <a:ext cx="1683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SG101 (44kDa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0B022C0-69B7-4484-55DF-6B084D225D39}"/>
              </a:ext>
            </a:extLst>
          </p:cNvPr>
          <p:cNvSpPr txBox="1"/>
          <p:nvPr/>
        </p:nvSpPr>
        <p:spPr>
          <a:xfrm>
            <a:off x="3063188" y="4659905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9298CC6-33F7-62FA-657E-C8C2D9D8F9A1}"/>
              </a:ext>
            </a:extLst>
          </p:cNvPr>
          <p:cNvSpPr txBox="1"/>
          <p:nvPr/>
        </p:nvSpPr>
        <p:spPr>
          <a:xfrm>
            <a:off x="3058814" y="5006826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pic>
        <p:nvPicPr>
          <p:cNvPr id="3" name="Picture 2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C2BF2FD2-E031-90DA-35B6-E4CF136694C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7527" b="57555"/>
          <a:stretch/>
        </p:blipFill>
        <p:spPr>
          <a:xfrm>
            <a:off x="6989856" y="1855440"/>
            <a:ext cx="4751040" cy="12213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69690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23A8D335-B9A2-195B-92AA-60B92878A65B}"/>
              </a:ext>
            </a:extLst>
          </p:cNvPr>
          <p:cNvSpPr txBox="1"/>
          <p:nvPr/>
        </p:nvSpPr>
        <p:spPr>
          <a:xfrm>
            <a:off x="338561" y="1509990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D6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5CF5E2E-63A6-E2CC-28A4-40B2F4757615}"/>
              </a:ext>
            </a:extLst>
          </p:cNvPr>
          <p:cNvSpPr txBox="1"/>
          <p:nvPr/>
        </p:nvSpPr>
        <p:spPr>
          <a:xfrm>
            <a:off x="233448" y="1929745"/>
            <a:ext cx="8002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8" name="Picture 7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21ED41AC-733B-546F-A2AE-E5999F97C0D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705" t="28113" r="17636" b="58943"/>
          <a:stretch/>
        </p:blipFill>
        <p:spPr>
          <a:xfrm>
            <a:off x="1026541" y="1893470"/>
            <a:ext cx="3093761" cy="405580"/>
          </a:xfrm>
          <a:prstGeom prst="rect">
            <a:avLst/>
          </a:prstGeom>
        </p:spPr>
      </p:pic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1A4B3CC7-5F3E-551B-E638-36555F40D5E3}"/>
              </a:ext>
            </a:extLst>
          </p:cNvPr>
          <p:cNvCxnSpPr>
            <a:cxnSpLocks/>
          </p:cNvCxnSpPr>
          <p:nvPr/>
        </p:nvCxnSpPr>
        <p:spPr>
          <a:xfrm>
            <a:off x="1280008" y="1349400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8427F954-2054-3FA2-392D-84B20461405D}"/>
              </a:ext>
            </a:extLst>
          </p:cNvPr>
          <p:cNvCxnSpPr>
            <a:cxnSpLocks/>
          </p:cNvCxnSpPr>
          <p:nvPr/>
        </p:nvCxnSpPr>
        <p:spPr>
          <a:xfrm>
            <a:off x="1711188" y="1356837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6AC9FEDA-677A-B74D-A7AB-0B4CF0863EB0}"/>
              </a:ext>
            </a:extLst>
          </p:cNvPr>
          <p:cNvCxnSpPr>
            <a:cxnSpLocks/>
          </p:cNvCxnSpPr>
          <p:nvPr/>
        </p:nvCxnSpPr>
        <p:spPr>
          <a:xfrm>
            <a:off x="2175819" y="1353123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44A84719-BBEC-A831-E806-0D2B6E15D820}"/>
              </a:ext>
            </a:extLst>
          </p:cNvPr>
          <p:cNvCxnSpPr>
            <a:cxnSpLocks/>
          </p:cNvCxnSpPr>
          <p:nvPr/>
        </p:nvCxnSpPr>
        <p:spPr>
          <a:xfrm>
            <a:off x="2595845" y="1360560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E42C5398-0DE2-6D98-2B5D-F54F52826604}"/>
              </a:ext>
            </a:extLst>
          </p:cNvPr>
          <p:cNvCxnSpPr>
            <a:cxnSpLocks/>
          </p:cNvCxnSpPr>
          <p:nvPr/>
        </p:nvCxnSpPr>
        <p:spPr>
          <a:xfrm>
            <a:off x="3049329" y="1356846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3CE80F47-F61F-6FB1-520E-B2A5FB219F06}"/>
              </a:ext>
            </a:extLst>
          </p:cNvPr>
          <p:cNvCxnSpPr>
            <a:cxnSpLocks/>
          </p:cNvCxnSpPr>
          <p:nvPr/>
        </p:nvCxnSpPr>
        <p:spPr>
          <a:xfrm>
            <a:off x="3513962" y="1353130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D227C0FC-6F4D-F44A-D5E0-57A80E29993C}"/>
              </a:ext>
            </a:extLst>
          </p:cNvPr>
          <p:cNvSpPr txBox="1"/>
          <p:nvPr/>
        </p:nvSpPr>
        <p:spPr>
          <a:xfrm>
            <a:off x="1627310" y="982006"/>
            <a:ext cx="54534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CFDEA24-2DF1-BDEC-EE41-96958161B7E8}"/>
              </a:ext>
            </a:extLst>
          </p:cNvPr>
          <p:cNvSpPr txBox="1"/>
          <p:nvPr/>
        </p:nvSpPr>
        <p:spPr>
          <a:xfrm>
            <a:off x="1269254" y="1121592"/>
            <a:ext cx="5604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CE83847B-8885-B6FD-70D4-26F580BC6B2F}"/>
              </a:ext>
            </a:extLst>
          </p:cNvPr>
          <p:cNvCxnSpPr>
            <a:cxnSpLocks/>
          </p:cNvCxnSpPr>
          <p:nvPr/>
        </p:nvCxnSpPr>
        <p:spPr>
          <a:xfrm>
            <a:off x="2172381" y="1006715"/>
            <a:ext cx="172677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1D0546B7-C581-3972-0B51-6C82160A5FBC}"/>
              </a:ext>
            </a:extLst>
          </p:cNvPr>
          <p:cNvSpPr txBox="1"/>
          <p:nvPr/>
        </p:nvSpPr>
        <p:spPr>
          <a:xfrm>
            <a:off x="2538624" y="700825"/>
            <a:ext cx="11416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osomes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55D1A86F-4406-FE39-EF0F-D09CDEBCAEF4}"/>
              </a:ext>
            </a:extLst>
          </p:cNvPr>
          <p:cNvSpPr txBox="1"/>
          <p:nvPr/>
        </p:nvSpPr>
        <p:spPr>
          <a:xfrm>
            <a:off x="2130017" y="1132053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2F0441B-7FC1-5E7B-5FC4-DB8E766ABCFB}"/>
              </a:ext>
            </a:extLst>
          </p:cNvPr>
          <p:cNvSpPr txBox="1"/>
          <p:nvPr/>
        </p:nvSpPr>
        <p:spPr>
          <a:xfrm>
            <a:off x="2550732" y="1130111"/>
            <a:ext cx="763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NK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0DF7B01F-5624-CD6D-5538-C0A20046109B}"/>
              </a:ext>
            </a:extLst>
          </p:cNvPr>
          <p:cNvSpPr txBox="1"/>
          <p:nvPr/>
        </p:nvSpPr>
        <p:spPr>
          <a:xfrm>
            <a:off x="2951489" y="1117186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8A7DFA9-56EC-CCC4-DB9B-853D5C513164}"/>
              </a:ext>
            </a:extLst>
          </p:cNvPr>
          <p:cNvSpPr txBox="1"/>
          <p:nvPr/>
        </p:nvSpPr>
        <p:spPr>
          <a:xfrm>
            <a:off x="3460728" y="979659"/>
            <a:ext cx="6595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+pNK</a:t>
            </a:r>
          </a:p>
        </p:txBody>
      </p:sp>
      <p:pic>
        <p:nvPicPr>
          <p:cNvPr id="5" name="Picture 4" descr="A close-up of a document&#10;&#10;Description automatically generated with low confidence">
            <a:extLst>
              <a:ext uri="{FF2B5EF4-FFF2-40B4-BE49-F238E27FC236}">
                <a16:creationId xmlns:a16="http://schemas.microsoft.com/office/drawing/2014/main" id="{53F0C900-B36D-24FC-BEF6-9AB163CBC94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8000" contrast="5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256" t="19512" r="7914" b="57943"/>
          <a:stretch/>
        </p:blipFill>
        <p:spPr>
          <a:xfrm>
            <a:off x="1033667" y="1435851"/>
            <a:ext cx="3093761" cy="400110"/>
          </a:xfrm>
          <a:prstGeom prst="rect">
            <a:avLst/>
          </a:prstGeom>
        </p:spPr>
      </p:pic>
      <p:pic>
        <p:nvPicPr>
          <p:cNvPr id="10" name="Picture 9" descr="A close-up of a tombstone&#10;&#10;Description automatically generated with medium confidence">
            <a:extLst>
              <a:ext uri="{FF2B5EF4-FFF2-40B4-BE49-F238E27FC236}">
                <a16:creationId xmlns:a16="http://schemas.microsoft.com/office/drawing/2014/main" id="{FB3EE41E-7E84-C945-0BF8-8FC9497A6D6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38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67" t="28284" r="6607" b="50368"/>
          <a:stretch/>
        </p:blipFill>
        <p:spPr>
          <a:xfrm>
            <a:off x="1026540" y="2401483"/>
            <a:ext cx="3093761" cy="40233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C8C5BBC-87A0-A863-0C06-06DBC18ADD83}"/>
              </a:ext>
            </a:extLst>
          </p:cNvPr>
          <p:cNvSpPr txBox="1"/>
          <p:nvPr/>
        </p:nvSpPr>
        <p:spPr>
          <a:xfrm>
            <a:off x="207799" y="2441858"/>
            <a:ext cx="851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SG10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E4D62B8-04F1-83D0-D2EA-49D7CC7DCB2B}"/>
              </a:ext>
            </a:extLst>
          </p:cNvPr>
          <p:cNvSpPr txBox="1"/>
          <p:nvPr/>
        </p:nvSpPr>
        <p:spPr>
          <a:xfrm>
            <a:off x="2246686" y="84159"/>
            <a:ext cx="54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</a:t>
            </a:r>
          </a:p>
        </p:txBody>
      </p:sp>
    </p:spTree>
    <p:extLst>
      <p:ext uri="{BB962C8B-B14F-4D97-AF65-F5344CB8AC3E}">
        <p14:creationId xmlns:p14="http://schemas.microsoft.com/office/powerpoint/2010/main" val="18046275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</TotalTime>
  <Words>460</Words>
  <Application>Microsoft Macintosh PowerPoint</Application>
  <PresentationFormat>Widescreen</PresentationFormat>
  <Paragraphs>154</Paragraphs>
  <Slides>4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ane Pereira</dc:creator>
  <cp:lastModifiedBy>Sodhi, Komal</cp:lastModifiedBy>
  <cp:revision>23</cp:revision>
  <dcterms:created xsi:type="dcterms:W3CDTF">2022-07-26T13:18:04Z</dcterms:created>
  <dcterms:modified xsi:type="dcterms:W3CDTF">2022-08-11T00:22:07Z</dcterms:modified>
</cp:coreProperties>
</file>